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5" r:id="rId2"/>
  </p:sldIdLst>
  <p:sldSz cx="9144000" cy="6858000" type="screen4x3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59" d="100"/>
          <a:sy n="59" d="100"/>
        </p:scale>
        <p:origin x="67" y="653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8C38C-3AB5-4BB6-AB51-B3B95EA19670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B2D7C-CB82-4C43-B7E5-2C84956EA00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039326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8C38C-3AB5-4BB6-AB51-B3B95EA19670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B2D7C-CB82-4C43-B7E5-2C84956EA00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743461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8C38C-3AB5-4BB6-AB51-B3B95EA19670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B2D7C-CB82-4C43-B7E5-2C84956EA00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497069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8C38C-3AB5-4BB6-AB51-B3B95EA19670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B2D7C-CB82-4C43-B7E5-2C84956EA00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133886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8C38C-3AB5-4BB6-AB51-B3B95EA19670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B2D7C-CB82-4C43-B7E5-2C84956EA00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215423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8C38C-3AB5-4BB6-AB51-B3B95EA19670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B2D7C-CB82-4C43-B7E5-2C84956EA00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31818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8C38C-3AB5-4BB6-AB51-B3B95EA19670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B2D7C-CB82-4C43-B7E5-2C84956EA00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726489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8C38C-3AB5-4BB6-AB51-B3B95EA19670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B2D7C-CB82-4C43-B7E5-2C84956EA00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306831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8C38C-3AB5-4BB6-AB51-B3B95EA19670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B2D7C-CB82-4C43-B7E5-2C84956EA00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929486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8C38C-3AB5-4BB6-AB51-B3B95EA19670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B2D7C-CB82-4C43-B7E5-2C84956EA00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444643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8C38C-3AB5-4BB6-AB51-B3B95EA19670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B2D7C-CB82-4C43-B7E5-2C84956EA00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482513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08C38C-3AB5-4BB6-AB51-B3B95EA19670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2B2D7C-CB82-4C43-B7E5-2C84956EA00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014212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CuadroTexto 27">
            <a:extLst>
              <a:ext uri="{FF2B5EF4-FFF2-40B4-BE49-F238E27FC236}">
                <a16:creationId xmlns:a16="http://schemas.microsoft.com/office/drawing/2014/main" id="{8A08BCCF-F1F9-4DB4-BEA4-C66BF5217690}"/>
              </a:ext>
            </a:extLst>
          </p:cNvPr>
          <p:cNvSpPr txBox="1"/>
          <p:nvPr/>
        </p:nvSpPr>
        <p:spPr>
          <a:xfrm>
            <a:off x="474181" y="210239"/>
            <a:ext cx="8408561" cy="6131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4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ating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ategy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ecific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K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rker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ow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tometry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s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own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Figure 4. Data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n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presentative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onor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re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own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</p:txBody>
      </p:sp>
      <p:pic>
        <p:nvPicPr>
          <p:cNvPr id="2" name="Imagen 1">
            <a:extLst>
              <a:ext uri="{FF2B5EF4-FFF2-40B4-BE49-F238E27FC236}">
                <a16:creationId xmlns:a16="http://schemas.microsoft.com/office/drawing/2014/main" id="{726D7B0C-1656-4E5F-AF72-CA2184367D0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50000"/>
          <a:stretch/>
        </p:blipFill>
        <p:spPr>
          <a:xfrm>
            <a:off x="648945" y="823356"/>
            <a:ext cx="3923055" cy="5493844"/>
          </a:xfrm>
          <a:prstGeom prst="rect">
            <a:avLst/>
          </a:prstGeom>
        </p:spPr>
      </p:pic>
      <p:pic>
        <p:nvPicPr>
          <p:cNvPr id="16" name="Imagen 15">
            <a:extLst>
              <a:ext uri="{FF2B5EF4-FFF2-40B4-BE49-F238E27FC236}">
                <a16:creationId xmlns:a16="http://schemas.microsoft.com/office/drawing/2014/main" id="{B22AB962-8D9D-4231-82EF-5E3BC765DFB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31339" y="836023"/>
            <a:ext cx="4571237" cy="55763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4304583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99</TotalTime>
  <Words>32</Words>
  <Application>Microsoft Office PowerPoint</Application>
  <PresentationFormat>Presentación en pantalla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ia Teresa Coiras Lopez</dc:creator>
  <cp:lastModifiedBy>Mayte Coiras</cp:lastModifiedBy>
  <cp:revision>113</cp:revision>
  <cp:lastPrinted>2020-10-15T14:54:18Z</cp:lastPrinted>
  <dcterms:created xsi:type="dcterms:W3CDTF">2020-07-22T13:38:22Z</dcterms:created>
  <dcterms:modified xsi:type="dcterms:W3CDTF">2022-02-24T22:42:53Z</dcterms:modified>
</cp:coreProperties>
</file>